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30" d="100"/>
          <a:sy n="30" d="100"/>
        </p:scale>
        <p:origin x="-25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8BD761-24E1-E148-8A84-28F5DCC6975F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A478BB-757F-264B-9436-808D1AA8C5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008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31083D-CBB2-CB42-AB47-D62DEBA6FDE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051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094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764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436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268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683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557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136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354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591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34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113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C4E56-392E-3F4B-9631-01F4D4A7E4A5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11C08-D6A6-E04D-AE9E-52D113057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329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7433119"/>
              </p:ext>
            </p:extLst>
          </p:nvPr>
        </p:nvGraphicFramePr>
        <p:xfrm>
          <a:off x="459610" y="561190"/>
          <a:ext cx="7887014" cy="4450080"/>
        </p:xfrm>
        <a:graphic>
          <a:graphicData uri="http://schemas.openxmlformats.org/drawingml/2006/table">
            <a:tbl>
              <a:tblPr firstRow="1" bandRow="1">
                <a:effectLst/>
                <a:tableStyleId>{5940675A-B579-460E-94D1-54222C63F5DA}</a:tableStyleId>
              </a:tblPr>
              <a:tblGrid>
                <a:gridCol w="90200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200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207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Fe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90.1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60.0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10.0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260.0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90.07</a:t>
                      </a:r>
                      <a:r>
                        <a:rPr lang="en-US" sz="1200" baseline="3000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010.12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46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510.14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340.11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270.13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990.16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110.13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2.250.08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60.16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,cc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50.12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,cccc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680.09</a:t>
                      </a:r>
                      <a:r>
                        <a:rPr lang="en-US" sz="1200" baseline="3000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,c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 Regimen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Male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Stress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Recovery</a:t>
                      </a:r>
                      <a:endParaRPr lang="en-US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wt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Epac1/2</a:t>
                      </a:r>
                      <a:r>
                        <a:rPr lang="en-US" sz="1200" b="1" baseline="300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-/-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No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 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1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0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70.0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1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30.06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0h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160.1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5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20.03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01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07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740.19</a:t>
                      </a:r>
                      <a:r>
                        <a:rPr lang="en-US" sz="12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b</a:t>
                      </a:r>
                      <a:endParaRPr lang="en-US" sz="1200" baseline="300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380.14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610.07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870.12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aaa,bbbb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30 min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ＭＳ 明朝"/>
                          <a:cs typeface="Times New Roman"/>
                        </a:rPr>
                        <a:t>2hr</a:t>
                      </a:r>
                      <a:endParaRPr lang="en-US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470.06</a:t>
                      </a:r>
                      <a:r>
                        <a:rPr lang="en-US" sz="1200" baseline="300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29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11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1.43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12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a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0.920.08</a:t>
                      </a:r>
                      <a:r>
                        <a:rPr lang="en-US" sz="1200" baseline="30000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ＭＳ 明朝"/>
                          <a:cs typeface="Times New Roman"/>
                          <a:sym typeface="Symbol"/>
                        </a:rPr>
                        <a:t>cccc</a:t>
                      </a:r>
                      <a:endParaRPr lang="en-US" sz="1200" baseline="30000" dirty="0">
                        <a:solidFill>
                          <a:srgbClr val="000000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4190" y="18180"/>
            <a:ext cx="9317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000000"/>
                </a:solidFill>
                <a:latin typeface="Times New Roman"/>
                <a:cs typeface="Times New Roman"/>
              </a:rPr>
              <a:t>S6 Table</a:t>
            </a:r>
            <a:endParaRPr lang="en-US" sz="16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4190" y="5466924"/>
            <a:ext cx="7765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/>
                <a:cs typeface="Times New Roman"/>
              </a:rPr>
              <a:t>S6 Table.</a:t>
            </a:r>
            <a:r>
              <a:rPr lang="en-US" sz="1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400" b="1" dirty="0">
                <a:latin typeface="Times New Roman"/>
                <a:cs typeface="Times New Roman"/>
              </a:rPr>
              <a:t>Comparison of </a:t>
            </a:r>
            <a:r>
              <a:rPr lang="en-US" sz="1400" b="1" dirty="0" err="1" smtClean="0">
                <a:latin typeface="Times New Roman"/>
                <a:cs typeface="Times New Roman"/>
              </a:rPr>
              <a:t>Ngfi</a:t>
            </a:r>
            <a:r>
              <a:rPr lang="en-US" sz="1400" b="1" dirty="0" smtClean="0">
                <a:latin typeface="Times New Roman"/>
                <a:cs typeface="Times New Roman"/>
              </a:rPr>
              <a:t>-</a:t>
            </a:r>
            <a:r>
              <a:rPr lang="en-US" sz="1400" b="1" dirty="0">
                <a:latin typeface="Times New Roman"/>
                <a:cs typeface="Times New Roman"/>
              </a:rPr>
              <a:t>A mRNA levels </a:t>
            </a:r>
            <a:r>
              <a:rPr lang="en-US" sz="1400" b="1" dirty="0" smtClean="0">
                <a:latin typeface="Times New Roman"/>
                <a:cs typeface="Times New Roman"/>
              </a:rPr>
              <a:t>in </a:t>
            </a:r>
            <a:r>
              <a:rPr lang="en-US" sz="1400" b="1" dirty="0">
                <a:latin typeface="Times New Roman"/>
                <a:cs typeface="Times New Roman"/>
              </a:rPr>
              <a:t>unstressed </a:t>
            </a:r>
            <a:r>
              <a:rPr lang="en-US" sz="1400" b="1" i="1" dirty="0" smtClean="0">
                <a:latin typeface="Times New Roman"/>
                <a:cs typeface="Times New Roman"/>
              </a:rPr>
              <a:t>vs. </a:t>
            </a:r>
            <a:r>
              <a:rPr lang="en-US" sz="1400" b="1" dirty="0">
                <a:latin typeface="Times New Roman"/>
                <a:cs typeface="Times New Roman"/>
              </a:rPr>
              <a:t>stressed mice. </a:t>
            </a:r>
            <a:endParaRPr lang="en-US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745475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Macintosh PowerPoint</Application>
  <PresentationFormat>On-screen Show (4:3)</PresentationFormat>
  <Paragraphs>7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42:18Z</dcterms:created>
  <dcterms:modified xsi:type="dcterms:W3CDTF">2018-03-05T13:42:35Z</dcterms:modified>
</cp:coreProperties>
</file>